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6" d="100"/>
          <a:sy n="76" d="100"/>
        </p:scale>
        <p:origin x="-3456" y="-11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44075D-E68E-483A-86B9-7DD516735B9A}" type="datetimeFigureOut">
              <a:rPr lang="de-DE" smtClean="0"/>
              <a:t>10.04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6E7D3-F552-43C4-A4B7-A94C17DB6B8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029797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44075D-E68E-483A-86B9-7DD516735B9A}" type="datetimeFigureOut">
              <a:rPr lang="de-DE" smtClean="0"/>
              <a:t>10.04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6E7D3-F552-43C4-A4B7-A94C17DB6B8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761991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44075D-E68E-483A-86B9-7DD516735B9A}" type="datetimeFigureOut">
              <a:rPr lang="de-DE" smtClean="0"/>
              <a:t>10.04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6E7D3-F552-43C4-A4B7-A94C17DB6B8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389529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44075D-E68E-483A-86B9-7DD516735B9A}" type="datetimeFigureOut">
              <a:rPr lang="de-DE" smtClean="0"/>
              <a:t>10.04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6E7D3-F552-43C4-A4B7-A94C17DB6B8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140178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44075D-E68E-483A-86B9-7DD516735B9A}" type="datetimeFigureOut">
              <a:rPr lang="de-DE" smtClean="0"/>
              <a:t>10.04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6E7D3-F552-43C4-A4B7-A94C17DB6B8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840015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44075D-E68E-483A-86B9-7DD516735B9A}" type="datetimeFigureOut">
              <a:rPr lang="de-DE" smtClean="0"/>
              <a:t>10.04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6E7D3-F552-43C4-A4B7-A94C17DB6B8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538441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44075D-E68E-483A-86B9-7DD516735B9A}" type="datetimeFigureOut">
              <a:rPr lang="de-DE" smtClean="0"/>
              <a:t>10.04.2017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6E7D3-F552-43C4-A4B7-A94C17DB6B8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646056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44075D-E68E-483A-86B9-7DD516735B9A}" type="datetimeFigureOut">
              <a:rPr lang="de-DE" smtClean="0"/>
              <a:t>10.04.2017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6E7D3-F552-43C4-A4B7-A94C17DB6B8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402586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44075D-E68E-483A-86B9-7DD516735B9A}" type="datetimeFigureOut">
              <a:rPr lang="de-DE" smtClean="0"/>
              <a:t>10.04.2017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6E7D3-F552-43C4-A4B7-A94C17DB6B8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964407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44075D-E68E-483A-86B9-7DD516735B9A}" type="datetimeFigureOut">
              <a:rPr lang="de-DE" smtClean="0"/>
              <a:t>10.04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6E7D3-F552-43C4-A4B7-A94C17DB6B8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296737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44075D-E68E-483A-86B9-7DD516735B9A}" type="datetimeFigureOut">
              <a:rPr lang="de-DE" smtClean="0"/>
              <a:t>10.04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6E7D3-F552-43C4-A4B7-A94C17DB6B8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499417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44075D-E68E-483A-86B9-7DD516735B9A}" type="datetimeFigureOut">
              <a:rPr lang="de-DE" smtClean="0"/>
              <a:t>10.04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16E7D3-F552-43C4-A4B7-A94C17DB6B8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688037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1200" y="1064568"/>
            <a:ext cx="5435600" cy="6848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Rechteck 3"/>
          <p:cNvSpPr/>
          <p:nvPr/>
        </p:nvSpPr>
        <p:spPr>
          <a:xfrm>
            <a:off x="711200" y="8193360"/>
            <a:ext cx="5435600" cy="9387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S1: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Exemplary histopathological phenomena of the liver used for scoring in the histological activity index (HAI).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Inflammation;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portal field showing granulocyte infiltration;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arrow = eosinophil granulocytes;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D)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arrow = neutrophil granulocyte;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E)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focal necrosis (circles);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F)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confluent necrosis;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G)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haemorrhage;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H)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healthy liver tissue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97999958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6</Words>
  <Application>Microsoft Office PowerPoint</Application>
  <PresentationFormat>A4-Papier (210x297 mm)</PresentationFormat>
  <Paragraphs>1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Universitätsklinikum Magdeburg A.ö.R.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ahlert, Stefan</dc:creator>
  <cp:lastModifiedBy>Kahlert, Stefan</cp:lastModifiedBy>
  <cp:revision>2</cp:revision>
  <dcterms:created xsi:type="dcterms:W3CDTF">2017-04-10T06:08:52Z</dcterms:created>
  <dcterms:modified xsi:type="dcterms:W3CDTF">2017-04-10T06:12:57Z</dcterms:modified>
</cp:coreProperties>
</file>